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FFF"/>
    <a:srgbClr val="00B2EE"/>
    <a:srgbClr val="E26714"/>
    <a:srgbClr val="C39B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300" d="100"/>
          <a:sy n="300" d="100"/>
        </p:scale>
        <p:origin x="216" y="-499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E225E-72F0-4853-92EE-6FDCB98569E6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C97A42-A716-4F81-9DB1-CE1E91B500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7540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1pPr>
    <a:lvl2pPr marL="40444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2pPr>
    <a:lvl3pPr marL="80887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3pPr>
    <a:lvl4pPr marL="121331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4pPr>
    <a:lvl5pPr marL="161775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5pPr>
    <a:lvl6pPr marL="202219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6pPr>
    <a:lvl7pPr marL="2426637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7pPr>
    <a:lvl8pPr marL="283107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8pPr>
    <a:lvl9pPr marL="323551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28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2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726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50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201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910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22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091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510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2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160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07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4614" y="2608528"/>
            <a:ext cx="4294874" cy="2622196"/>
          </a:xfrm>
          <a:prstGeom prst="rect">
            <a:avLst/>
          </a:prstGeom>
        </p:spPr>
      </p:pic>
      <p:sp>
        <p:nvSpPr>
          <p:cNvPr id="67" name="TextBox 66"/>
          <p:cNvSpPr txBox="1"/>
          <p:nvPr/>
        </p:nvSpPr>
        <p:spPr>
          <a:xfrm>
            <a:off x="413859" y="7745918"/>
            <a:ext cx="60407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s of normality of gene expression data from non-muscle-invasive bladder cancer patient cohorts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 displayed confidence interval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I) plots of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obtained by Lilliefors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ch test the null hypothesis that data come from a normally distributed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. Each </a:t>
            </a:r>
            <a:r>
              <a:rPr lang="en-US" altLang="ko-KR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 was estimated across all genes in the data sets. Each dot indicat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</a:t>
            </a:r>
            <a:r>
              <a:rPr lang="en-US" altLang="ko-KR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Upper and lower bars indicate upper and lower values of 95% CI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significance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shold of significance was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BNU,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ungbuk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 Hospital.</a:t>
            </a:r>
          </a:p>
        </p:txBody>
      </p:sp>
      <p:grpSp>
        <p:nvGrpSpPr>
          <p:cNvPr id="23" name="그룹 22"/>
          <p:cNvGrpSpPr/>
          <p:nvPr/>
        </p:nvGrpSpPr>
        <p:grpSpPr>
          <a:xfrm>
            <a:off x="3877254" y="4014476"/>
            <a:ext cx="123825" cy="173831"/>
            <a:chOff x="3757613" y="3305175"/>
            <a:chExt cx="123825" cy="173831"/>
          </a:xfrm>
        </p:grpSpPr>
        <p:cxnSp>
          <p:nvCxnSpPr>
            <p:cNvPr id="16" name="직선 연결선 15"/>
            <p:cNvCxnSpPr/>
            <p:nvPr/>
          </p:nvCxnSpPr>
          <p:spPr>
            <a:xfrm>
              <a:off x="3819525" y="3305175"/>
              <a:ext cx="0" cy="17383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/>
            <p:cNvCxnSpPr/>
            <p:nvPr/>
          </p:nvCxnSpPr>
          <p:spPr>
            <a:xfrm>
              <a:off x="3757613" y="3307556"/>
              <a:ext cx="1238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/>
            <p:cNvCxnSpPr/>
            <p:nvPr/>
          </p:nvCxnSpPr>
          <p:spPr>
            <a:xfrm>
              <a:off x="3757613" y="3479006"/>
              <a:ext cx="1238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타원 21"/>
            <p:cNvSpPr/>
            <p:nvPr/>
          </p:nvSpPr>
          <p:spPr>
            <a:xfrm>
              <a:off x="3775471" y="3348036"/>
              <a:ext cx="88108" cy="8810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61" name="직선 연결선 60"/>
          <p:cNvCxnSpPr/>
          <p:nvPr/>
        </p:nvCxnSpPr>
        <p:spPr>
          <a:xfrm>
            <a:off x="1281691" y="3652525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>
            <a:off x="1281691" y="3745395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타원 62"/>
          <p:cNvSpPr/>
          <p:nvPr/>
        </p:nvSpPr>
        <p:spPr>
          <a:xfrm>
            <a:off x="1299549" y="3657287"/>
            <a:ext cx="88108" cy="8810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73" name="직선 연결선 72"/>
          <p:cNvCxnSpPr/>
          <p:nvPr/>
        </p:nvCxnSpPr>
        <p:spPr>
          <a:xfrm>
            <a:off x="2577091" y="4324037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2577091" y="4416907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타원 74"/>
          <p:cNvSpPr/>
          <p:nvPr/>
        </p:nvSpPr>
        <p:spPr>
          <a:xfrm>
            <a:off x="2594949" y="4328799"/>
            <a:ext cx="88108" cy="8810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76" name="직선 연결선 75"/>
          <p:cNvCxnSpPr/>
          <p:nvPr/>
        </p:nvCxnSpPr>
        <p:spPr>
          <a:xfrm>
            <a:off x="5182178" y="3285812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5182178" y="3378682"/>
            <a:ext cx="1238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타원 80"/>
          <p:cNvSpPr/>
          <p:nvPr/>
        </p:nvSpPr>
        <p:spPr>
          <a:xfrm>
            <a:off x="5200036" y="3290574"/>
            <a:ext cx="88108" cy="8810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418622" y="3606895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valu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823216" y="494801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823217" y="438447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6200000">
            <a:off x="823218" y="382059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6200000">
            <a:off x="823219" y="319575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 rot="16200000">
            <a:off x="823220" y="260901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/>
          <p:cNvCxnSpPr/>
          <p:nvPr/>
        </p:nvCxnSpPr>
        <p:spPr>
          <a:xfrm>
            <a:off x="1090729" y="4808861"/>
            <a:ext cx="440101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5403138" y="4688503"/>
            <a:ext cx="7521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eshold</a:t>
            </a:r>
          </a:p>
          <a:p>
            <a:r>
              <a:rPr lang="en-US" altLang="ko-K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0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5)</a:t>
            </a:r>
            <a:endParaRPr lang="ko-KR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067677" y="5279143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BNU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연결선 31"/>
          <p:cNvCxnSpPr/>
          <p:nvPr/>
        </p:nvCxnSpPr>
        <p:spPr>
          <a:xfrm>
            <a:off x="1334078" y="5212468"/>
            <a:ext cx="0" cy="974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261335" y="5279143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OMOL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직선 연결선 92"/>
          <p:cNvCxnSpPr/>
          <p:nvPr/>
        </p:nvCxnSpPr>
        <p:spPr>
          <a:xfrm>
            <a:off x="2639003" y="5212468"/>
            <a:ext cx="0" cy="974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3550294" y="5279143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uropea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직선 연결선 94"/>
          <p:cNvCxnSpPr/>
          <p:nvPr/>
        </p:nvCxnSpPr>
        <p:spPr>
          <a:xfrm>
            <a:off x="3937578" y="5212468"/>
            <a:ext cx="0" cy="974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690143" y="5279143"/>
            <a:ext cx="1098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BNU-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직선 연결선 96"/>
          <p:cNvCxnSpPr/>
          <p:nvPr/>
        </p:nvCxnSpPr>
        <p:spPr>
          <a:xfrm>
            <a:off x="5239328" y="5212468"/>
            <a:ext cx="0" cy="9740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2695914" y="5462365"/>
            <a:ext cx="13051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tient cohort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5749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76</TotalTime>
  <Words>115</Words>
  <Application>Microsoft Office PowerPoint</Application>
  <PresentationFormat>A4 용지(210x297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-Kyu Kim</dc:creator>
  <cp:lastModifiedBy>Seon-Kyu Kim</cp:lastModifiedBy>
  <cp:revision>1800</cp:revision>
  <dcterms:created xsi:type="dcterms:W3CDTF">2018-02-19T05:53:37Z</dcterms:created>
  <dcterms:modified xsi:type="dcterms:W3CDTF">2021-01-21T05:34:11Z</dcterms:modified>
</cp:coreProperties>
</file>